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519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88" autoAdjust="0"/>
    <p:restoredTop sz="94660"/>
  </p:normalViewPr>
  <p:slideViewPr>
    <p:cSldViewPr snapToGrid="0">
      <p:cViewPr varScale="1">
        <p:scale>
          <a:sx n="86" d="100"/>
          <a:sy n="86" d="100"/>
        </p:scale>
        <p:origin x="32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66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1AB1DDD-B0DF-47D9-86C6-6D8C5BD56A60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374F08C-DBF4-4895-B2E2-F73ADCA483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2948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605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908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46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308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498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6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677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737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082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906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57951-CE25-4057-BF31-7F8A9C4A52E8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B3C35-D21C-47E0-A231-DBE39F70F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885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6716C56-F660-4DFB-8223-57F2D59CEA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3561302"/>
              </p:ext>
            </p:extLst>
          </p:nvPr>
        </p:nvGraphicFramePr>
        <p:xfrm>
          <a:off x="637479" y="512473"/>
          <a:ext cx="2581280" cy="1891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6" name="Prism 9" r:id="rId3" imgW="4058369" imgH="2973072" progId="Prism9.Document">
                  <p:embed/>
                </p:oleObj>
              </mc:Choice>
              <mc:Fallback>
                <p:oleObj name="Prism 9" r:id="rId3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7479" y="512473"/>
                        <a:ext cx="2581280" cy="1891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BA57983-E0E5-4B76-A58C-E6BAD67CD0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8533797"/>
              </p:ext>
            </p:extLst>
          </p:nvPr>
        </p:nvGraphicFramePr>
        <p:xfrm>
          <a:off x="637479" y="2403997"/>
          <a:ext cx="2581281" cy="189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7" name="Prism 9" r:id="rId5" imgW="4058369" imgH="2973072" progId="Prism9.Document">
                  <p:embed/>
                </p:oleObj>
              </mc:Choice>
              <mc:Fallback>
                <p:oleObj name="Prism 9" r:id="rId5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37479" y="2403997"/>
                        <a:ext cx="2581281" cy="1891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D52E2FE-40E9-4180-A7B1-C5552766EB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6107659"/>
              </p:ext>
            </p:extLst>
          </p:nvPr>
        </p:nvGraphicFramePr>
        <p:xfrm>
          <a:off x="637479" y="4437296"/>
          <a:ext cx="2581281" cy="189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8" name="Prism 9" r:id="rId7" imgW="4058369" imgH="2973072" progId="Prism9.Document">
                  <p:embed/>
                </p:oleObj>
              </mc:Choice>
              <mc:Fallback>
                <p:oleObj name="Prism 9" r:id="rId7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7479" y="4437296"/>
                        <a:ext cx="2581281" cy="1891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3B6665C-1B4C-45C0-9F4A-A1FA274397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7146654"/>
              </p:ext>
            </p:extLst>
          </p:nvPr>
        </p:nvGraphicFramePr>
        <p:xfrm>
          <a:off x="637480" y="6470595"/>
          <a:ext cx="2581279" cy="1891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9" name="Prism 9" r:id="rId9" imgW="4058369" imgH="2973072" progId="Prism9.Document">
                  <p:embed/>
                </p:oleObj>
              </mc:Choice>
              <mc:Fallback>
                <p:oleObj name="Prism 9" r:id="rId9" imgW="4058369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37480" y="6470595"/>
                        <a:ext cx="2581279" cy="1891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D074DBB-FF9A-4260-BEEF-0CAA659D39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9738963"/>
              </p:ext>
            </p:extLst>
          </p:nvPr>
        </p:nvGraphicFramePr>
        <p:xfrm>
          <a:off x="3292414" y="512473"/>
          <a:ext cx="2956960" cy="1891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0" name="Prism 9" r:id="rId11" imgW="4648272" imgH="2973072" progId="Prism9.Document">
                  <p:embed/>
                </p:oleObj>
              </mc:Choice>
              <mc:Fallback>
                <p:oleObj name="Prism 9" r:id="rId11" imgW="4648272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292414" y="512473"/>
                        <a:ext cx="2956960" cy="1891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0EFDF6B-8856-4805-A8E3-B13777E49A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5515275"/>
              </p:ext>
            </p:extLst>
          </p:nvPr>
        </p:nvGraphicFramePr>
        <p:xfrm>
          <a:off x="3298473" y="2403997"/>
          <a:ext cx="2950901" cy="189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1" name="Prism 9" r:id="rId13" imgW="4639268" imgH="2973072" progId="Prism9.Document">
                  <p:embed/>
                </p:oleObj>
              </mc:Choice>
              <mc:Fallback>
                <p:oleObj name="Prism 9" r:id="rId13" imgW="4639268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298473" y="2403997"/>
                        <a:ext cx="2950901" cy="1891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0FC8C53D-0EAD-497F-B787-7D61AD9730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6220000"/>
              </p:ext>
            </p:extLst>
          </p:nvPr>
        </p:nvGraphicFramePr>
        <p:xfrm>
          <a:off x="3292416" y="4437296"/>
          <a:ext cx="2956958" cy="1891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2" name="Prism 9" r:id="rId15" imgW="4648272" imgH="2973072" progId="Prism9.Document">
                  <p:embed/>
                </p:oleObj>
              </mc:Choice>
              <mc:Fallback>
                <p:oleObj name="Prism 9" r:id="rId15" imgW="4648272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292416" y="4437296"/>
                        <a:ext cx="2956958" cy="1891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274B36E2-FB4D-4D22-9C9F-1065CB5E07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4278859"/>
              </p:ext>
            </p:extLst>
          </p:nvPr>
        </p:nvGraphicFramePr>
        <p:xfrm>
          <a:off x="3303524" y="6470594"/>
          <a:ext cx="2945850" cy="18915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13" name="Prism 9" r:id="rId17" imgW="4630265" imgH="2973072" progId="Prism9.Document">
                  <p:embed/>
                </p:oleObj>
              </mc:Choice>
              <mc:Fallback>
                <p:oleObj name="Prism 9" r:id="rId17" imgW="4630265" imgH="297307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303524" y="6470594"/>
                        <a:ext cx="2945850" cy="18915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DE296E7-79A9-436E-8821-0EBD5778B829}"/>
              </a:ext>
            </a:extLst>
          </p:cNvPr>
          <p:cNvSpPr txBox="1"/>
          <p:nvPr/>
        </p:nvSpPr>
        <p:spPr>
          <a:xfrm>
            <a:off x="2884174" y="160124"/>
            <a:ext cx="17251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1B3F0B-F796-4701-B661-8FB083619105}"/>
              </a:ext>
            </a:extLst>
          </p:cNvPr>
          <p:cNvSpPr txBox="1"/>
          <p:nvPr/>
        </p:nvSpPr>
        <p:spPr>
          <a:xfrm>
            <a:off x="609878" y="479890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0A82D1-2390-490B-88DE-DF5C2222C899}"/>
              </a:ext>
            </a:extLst>
          </p:cNvPr>
          <p:cNvSpPr txBox="1"/>
          <p:nvPr/>
        </p:nvSpPr>
        <p:spPr>
          <a:xfrm>
            <a:off x="633219" y="2299250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869E953-475D-4920-AE15-8888A234ED9F}"/>
              </a:ext>
            </a:extLst>
          </p:cNvPr>
          <p:cNvSpPr txBox="1"/>
          <p:nvPr/>
        </p:nvSpPr>
        <p:spPr>
          <a:xfrm>
            <a:off x="621552" y="4391084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AB22DF9-E2C4-4789-B53F-18C68F11A73A}"/>
              </a:ext>
            </a:extLst>
          </p:cNvPr>
          <p:cNvSpPr txBox="1"/>
          <p:nvPr/>
        </p:nvSpPr>
        <p:spPr>
          <a:xfrm>
            <a:off x="622591" y="6420666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2CD53EA-4F57-466B-B393-B5AADD3553C9}"/>
              </a:ext>
            </a:extLst>
          </p:cNvPr>
          <p:cNvSpPr txBox="1"/>
          <p:nvPr/>
        </p:nvSpPr>
        <p:spPr>
          <a:xfrm>
            <a:off x="3290498" y="506430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425605C-CF09-417D-AC49-168460EE14C5}"/>
              </a:ext>
            </a:extLst>
          </p:cNvPr>
          <p:cNvSpPr txBox="1"/>
          <p:nvPr/>
        </p:nvSpPr>
        <p:spPr>
          <a:xfrm>
            <a:off x="3313837" y="2349645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7EEDDC2-BF19-4859-A518-603C738A66D5}"/>
              </a:ext>
            </a:extLst>
          </p:cNvPr>
          <p:cNvSpPr txBox="1"/>
          <p:nvPr/>
        </p:nvSpPr>
        <p:spPr>
          <a:xfrm>
            <a:off x="3270369" y="4417628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58E1D1E-4736-4538-B307-650D878B466F}"/>
              </a:ext>
            </a:extLst>
          </p:cNvPr>
          <p:cNvSpPr txBox="1"/>
          <p:nvPr/>
        </p:nvSpPr>
        <p:spPr>
          <a:xfrm>
            <a:off x="3263453" y="6447202"/>
            <a:ext cx="458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A4D2E39-7CC6-4E86-A7E8-AF88F878A649}"/>
              </a:ext>
            </a:extLst>
          </p:cNvPr>
          <p:cNvSpPr/>
          <p:nvPr/>
        </p:nvSpPr>
        <p:spPr>
          <a:xfrm>
            <a:off x="557558" y="8324799"/>
            <a:ext cx="586368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. Tumor burden of individual mouse received PANC-1 cells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mor volumes on the left (A-D) and the right (E-H) flanks were measured at different days after the start of treatments.     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2275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42</TotalTime>
  <Words>5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>Arizona State University OKE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mudur Rahman</dc:creator>
  <cp:lastModifiedBy>Masmudur Rahman</cp:lastModifiedBy>
  <cp:revision>400</cp:revision>
  <cp:lastPrinted>2022-07-28T21:46:33Z</cp:lastPrinted>
  <dcterms:created xsi:type="dcterms:W3CDTF">2018-11-27T16:44:45Z</dcterms:created>
  <dcterms:modified xsi:type="dcterms:W3CDTF">2023-05-05T00:10:52Z</dcterms:modified>
</cp:coreProperties>
</file>